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56" r:id="rId2"/>
    <p:sldId id="257" r:id="rId3"/>
  </p:sldIdLst>
  <p:sldSz cx="12192000" cy="10547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E1A8B75-CF9C-4B83-B9B6-4D45D4E7CFBB}" v="1" dt="2023-06-09T13:35:01.9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710" y="-15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26153"/>
            <a:ext cx="10363200" cy="367204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539801"/>
            <a:ext cx="9144000" cy="254650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20832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647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61549"/>
            <a:ext cx="2628900" cy="8938392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61549"/>
            <a:ext cx="7734300" cy="8938392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08685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87570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29516"/>
            <a:ext cx="10515600" cy="438740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058426"/>
            <a:ext cx="10515600" cy="2307232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2681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07743"/>
            <a:ext cx="5181600" cy="669219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07743"/>
            <a:ext cx="5181600" cy="669219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21115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61551"/>
            <a:ext cx="10515600" cy="2038667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585566"/>
            <a:ext cx="5157787" cy="126714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852713"/>
            <a:ext cx="5157787" cy="5666760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585566"/>
            <a:ext cx="5183188" cy="126714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852713"/>
            <a:ext cx="5183188" cy="5666760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93373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0324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12659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03157"/>
            <a:ext cx="3932237" cy="246104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18625"/>
            <a:ext cx="6172200" cy="749545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164205"/>
            <a:ext cx="3932237" cy="58620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96005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03157"/>
            <a:ext cx="3932237" cy="246104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18625"/>
            <a:ext cx="6172200" cy="749545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164205"/>
            <a:ext cx="3932237" cy="58620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44669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61551"/>
            <a:ext cx="10515600" cy="20386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07743"/>
            <a:ext cx="10515600" cy="66921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775833"/>
            <a:ext cx="2743200" cy="5615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D98F5-3791-4126-BAD4-8355D7E1E962}" type="datetimeFigureOut">
              <a:rPr lang="el-GR" smtClean="0"/>
              <a:t>7/9/202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775833"/>
            <a:ext cx="4114800" cy="5615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775833"/>
            <a:ext cx="2743200" cy="5615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C38BAE-39AD-4417-B9B5-9A098D8F0B9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7867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hyperlink" Target="mailto:dermon@upatras.gr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35FC21B-28D8-FEC6-2DE3-B0C991C35792}"/>
              </a:ext>
            </a:extLst>
          </p:cNvPr>
          <p:cNvSpPr txBox="1"/>
          <p:nvPr/>
        </p:nvSpPr>
        <p:spPr>
          <a:xfrm>
            <a:off x="4646295" y="67402"/>
            <a:ext cx="1729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upplementary material</a:t>
            </a:r>
            <a:endParaRPr lang="el-GR" sz="1200" b="1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006DD2-EE4C-EB63-1149-2D06B44E80EA}"/>
              </a:ext>
            </a:extLst>
          </p:cNvPr>
          <p:cNvSpPr txBox="1"/>
          <p:nvPr/>
        </p:nvSpPr>
        <p:spPr>
          <a:xfrm>
            <a:off x="1522095" y="419735"/>
            <a:ext cx="7671074" cy="1969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ocial withdrawal and anxiety-like behavior have an impact on zebrafish adult neurogenesis.</a:t>
            </a:r>
          </a:p>
          <a:p>
            <a:pPr algn="just">
              <a:spcBef>
                <a:spcPts val="12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Panagiotis Perdikaris</a:t>
            </a:r>
            <a:r>
              <a:rPr lang="en-US" sz="1200" b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, Paulina Prouska</a:t>
            </a:r>
            <a:r>
              <a:rPr lang="en-US" sz="1200" b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, Catherine R. Dermon</a:t>
            </a:r>
            <a:r>
              <a:rPr lang="en-US" sz="1200" b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endParaRPr lang="el-GR" sz="1200" b="1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spcBef>
                <a:spcPts val="1200"/>
              </a:spcBef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boratory of Human and Animal Physiology, Department of Biology, University of Patras, , Rio, 26500 Patras, Greece.</a:t>
            </a:r>
          </a:p>
          <a:p>
            <a:pPr marL="171450" indent="-171450" algn="just">
              <a:spcBef>
                <a:spcPts val="1200"/>
              </a:spcBef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ence: </a:t>
            </a:r>
            <a:b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therine R. Derm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ο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, </a:t>
            </a:r>
          </a:p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u="sng" dirty="0">
                <a:solidFill>
                  <a:srgbClr val="0000FF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dermon@upatras.gr</a:t>
            </a:r>
            <a:endParaRPr lang="en-US" sz="1200" u="sng" dirty="0">
              <a:solidFill>
                <a:srgbClr val="0000FF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919E7E-1094-D738-A3DA-F6A005D2A3B9}"/>
              </a:ext>
            </a:extLst>
          </p:cNvPr>
          <p:cNvSpPr txBox="1"/>
          <p:nvPr/>
        </p:nvSpPr>
        <p:spPr>
          <a:xfrm>
            <a:off x="1555893" y="9064340"/>
            <a:ext cx="97280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 Figure 1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ee-Dimensional (3-D) visualization of the expression of mGluR5 on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rdU+ cells in the neurogenic zone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V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Notice the high density of mGluR5 immunopositive puncta around BrdU-labeled cell nuclei. Image is representative of MK-801 long-term survival group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cale bar: 50 </a:t>
            </a:r>
            <a:r>
              <a:rPr lang="el-G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μ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.</a:t>
            </a:r>
            <a:endParaRPr lang="el-G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3D-PAROUSIASI">
            <a:hlinkClick r:id="" action="ppaction://media"/>
            <a:extLst>
              <a:ext uri="{FF2B5EF4-FFF2-40B4-BE49-F238E27FC236}">
                <a16:creationId xmlns:a16="http://schemas.microsoft.com/office/drawing/2014/main" id="{90C7841F-A228-F733-7119-054FF78DB3F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80658" y="2885438"/>
            <a:ext cx="9728002" cy="5472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C860487-117A-C41E-7AD7-060F752C2C88}"/>
              </a:ext>
            </a:extLst>
          </p:cNvPr>
          <p:cNvSpPr txBox="1"/>
          <p:nvPr/>
        </p:nvSpPr>
        <p:spPr>
          <a:xfrm>
            <a:off x="1546881" y="2562225"/>
            <a:ext cx="1815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1200"/>
              </a:spcBef>
              <a:spcAft>
                <a:spcPts val="12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 Figures:</a:t>
            </a:r>
            <a:endParaRPr kumimoji="0" lang="el-GR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0006722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Ομάδα 24">
            <a:extLst>
              <a:ext uri="{FF2B5EF4-FFF2-40B4-BE49-F238E27FC236}">
                <a16:creationId xmlns:a16="http://schemas.microsoft.com/office/drawing/2014/main" id="{E524D898-EB13-71C2-A0EA-ABDA2682EAE1}"/>
              </a:ext>
            </a:extLst>
          </p:cNvPr>
          <p:cNvGrpSpPr/>
          <p:nvPr/>
        </p:nvGrpSpPr>
        <p:grpSpPr>
          <a:xfrm>
            <a:off x="3995982" y="327576"/>
            <a:ext cx="2981216" cy="3316198"/>
            <a:chOff x="3995982" y="327576"/>
            <a:chExt cx="2981216" cy="3316198"/>
          </a:xfrm>
        </p:grpSpPr>
        <p:grpSp>
          <p:nvGrpSpPr>
            <p:cNvPr id="9" name="Ομάδα 8">
              <a:extLst>
                <a:ext uri="{FF2B5EF4-FFF2-40B4-BE49-F238E27FC236}">
                  <a16:creationId xmlns:a16="http://schemas.microsoft.com/office/drawing/2014/main" id="{58567123-CF8D-B716-812A-07EE39115A9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995982" y="327576"/>
              <a:ext cx="2981216" cy="3316198"/>
              <a:chOff x="9773349" y="2309005"/>
              <a:chExt cx="1755207" cy="2781494"/>
            </a:xfrm>
          </p:grpSpPr>
          <p:grpSp>
            <p:nvGrpSpPr>
              <p:cNvPr id="11" name="Ομάδα 10">
                <a:extLst>
                  <a:ext uri="{FF2B5EF4-FFF2-40B4-BE49-F238E27FC236}">
                    <a16:creationId xmlns:a16="http://schemas.microsoft.com/office/drawing/2014/main" id="{A8B7C8B2-C374-5A93-44D1-09C91643D134}"/>
                  </a:ext>
                </a:extLst>
              </p:cNvPr>
              <p:cNvGrpSpPr/>
              <p:nvPr/>
            </p:nvGrpSpPr>
            <p:grpSpPr>
              <a:xfrm>
                <a:off x="9773349" y="2309005"/>
                <a:ext cx="1630680" cy="2709672"/>
                <a:chOff x="6709257" y="3440851"/>
                <a:chExt cx="1630680" cy="2709672"/>
              </a:xfrm>
            </p:grpSpPr>
            <p:pic>
              <p:nvPicPr>
                <p:cNvPr id="18" name="Εικόνα 17" descr="Εικόνα που περιέχει στιγμιότυπο οθόνης, πολυχρωμία, σκοτάδι, πράσινο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C46B1BBC-8C07-7236-65E3-7DD9CEFD11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09257" y="3440851"/>
                  <a:ext cx="1630680" cy="2709672"/>
                </a:xfrm>
                <a:prstGeom prst="rect">
                  <a:avLst/>
                </a:prstGeom>
              </p:spPr>
            </p:pic>
            <p:sp>
              <p:nvSpPr>
                <p:cNvPr id="19" name="Ορθογώνιο 18">
                  <a:extLst>
                    <a:ext uri="{FF2B5EF4-FFF2-40B4-BE49-F238E27FC236}">
                      <a16:creationId xmlns:a16="http://schemas.microsoft.com/office/drawing/2014/main" id="{2B82DD89-105E-1AE0-89F2-BC42D85BCB7D}"/>
                    </a:ext>
                  </a:extLst>
                </p:cNvPr>
                <p:cNvSpPr/>
                <p:nvPr/>
              </p:nvSpPr>
              <p:spPr>
                <a:xfrm>
                  <a:off x="7954297" y="3647112"/>
                  <a:ext cx="324000" cy="348269"/>
                </a:xfrm>
                <a:prstGeom prst="rect">
                  <a:avLst/>
                </a:prstGeom>
                <a:noFill/>
                <a:ln>
                  <a:solidFill>
                    <a:schemeClr val="accent4"/>
                  </a:solidFill>
                  <a:prstDash val="dash"/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l-GR"/>
                </a:p>
              </p:txBody>
            </p:sp>
          </p:grpSp>
          <p:cxnSp>
            <p:nvCxnSpPr>
              <p:cNvPr id="12" name="Ευθύγραμμο βέλος σύνδεσης 11">
                <a:extLst>
                  <a:ext uri="{FF2B5EF4-FFF2-40B4-BE49-F238E27FC236}">
                    <a16:creationId xmlns:a16="http://schemas.microsoft.com/office/drawing/2014/main" id="{DBAB6DD9-AC8C-B551-3209-BE4EDABD67B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932759" y="2577584"/>
                <a:ext cx="0" cy="361950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Ευθύγραμμο βέλος σύνδεσης 12">
                <a:extLst>
                  <a:ext uri="{FF2B5EF4-FFF2-40B4-BE49-F238E27FC236}">
                    <a16:creationId xmlns:a16="http://schemas.microsoft.com/office/drawing/2014/main" id="{9D1A86FB-9C1E-5E17-B0B0-478D2544B80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10112236" y="2758556"/>
                <a:ext cx="0" cy="361950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C69AACB-7B84-7C3B-16EF-EB7932810149}"/>
                  </a:ext>
                </a:extLst>
              </p:cNvPr>
              <p:cNvSpPr txBox="1"/>
              <p:nvPr/>
            </p:nvSpPr>
            <p:spPr>
              <a:xfrm>
                <a:off x="9774617" y="2349835"/>
                <a:ext cx="599844" cy="232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Dorsal</a:t>
                </a:r>
                <a:endParaRPr lang="el-GR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22B4287F-23A2-81B4-52C8-D5A340B3A38F}"/>
                  </a:ext>
                </a:extLst>
              </p:cNvPr>
              <p:cNvSpPr txBox="1"/>
              <p:nvPr/>
            </p:nvSpPr>
            <p:spPr>
              <a:xfrm>
                <a:off x="10276668" y="2806136"/>
                <a:ext cx="589970" cy="232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lateral</a:t>
                </a:r>
                <a:endParaRPr lang="el-GR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31C492C-E0B8-47B5-D7CD-EA35177CC99B}"/>
                  </a:ext>
                </a:extLst>
              </p:cNvPr>
              <p:cNvSpPr txBox="1"/>
              <p:nvPr/>
            </p:nvSpPr>
            <p:spPr>
              <a:xfrm>
                <a:off x="9786064" y="4486588"/>
                <a:ext cx="626231" cy="6039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accent6"/>
                    </a:solidFill>
                  </a:rPr>
                  <a:t>BrdU</a:t>
                </a:r>
              </a:p>
              <a:p>
                <a:r>
                  <a:rPr lang="en-US" sz="1600" b="1" dirty="0">
                    <a:solidFill>
                      <a:srgbClr val="FF0000"/>
                    </a:solidFill>
                  </a:rPr>
                  <a:t>mGluR5</a:t>
                </a:r>
                <a:endParaRPr lang="el-GR" sz="16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9E6AC6F-4B91-7CC4-3E5A-24CC5AB773AB}"/>
                  </a:ext>
                </a:extLst>
              </p:cNvPr>
              <p:cNvSpPr txBox="1"/>
              <p:nvPr/>
            </p:nvSpPr>
            <p:spPr>
              <a:xfrm>
                <a:off x="11047334" y="4629051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</a:rPr>
                  <a:t>Dm</a:t>
                </a:r>
                <a:endParaRPr lang="el-GR" sz="1600" b="1" dirty="0"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21" name="Εικόνα 20" descr="Εικόνα που περιέχει πολυχρωμία, πράσινο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E0F053AA-54C6-97CE-E0B2-01D89714EA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33847" y="1483163"/>
              <a:ext cx="1243133" cy="1116000"/>
            </a:xfrm>
            <a:prstGeom prst="rect">
              <a:avLst/>
            </a:prstGeom>
            <a:ln w="19050">
              <a:solidFill>
                <a:schemeClr val="accent4"/>
              </a:solidFill>
              <a:prstDash val="dash"/>
            </a:ln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F078491E-9838-BEA0-34D5-763A75A8E659}"/>
              </a:ext>
            </a:extLst>
          </p:cNvPr>
          <p:cNvSpPr txBox="1"/>
          <p:nvPr/>
        </p:nvSpPr>
        <p:spPr>
          <a:xfrm>
            <a:off x="1251094" y="3697687"/>
            <a:ext cx="97280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 Figure 2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GluR5 (red) is expressed on the nuclear membrane of BrdU+ cell (green) in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rogenic zone of D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icrophotographic images are representative of control-long term group. Scale bar: 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l-G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118948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9</TotalTime>
  <Words>168</Words>
  <Application>Microsoft Office PowerPoint</Application>
  <PresentationFormat>Προσαρμογή</PresentationFormat>
  <Paragraphs>14</Paragraphs>
  <Slides>2</Slides>
  <Notes>0</Notes>
  <HiddenSlides>0</HiddenSlides>
  <MMClips>1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Θέμα του Office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panos perdikaris</dc:creator>
  <cp:lastModifiedBy>ΠΑΝΑΓΙΩΤΗΣ</cp:lastModifiedBy>
  <cp:revision>8</cp:revision>
  <dcterms:created xsi:type="dcterms:W3CDTF">2023-06-08T23:12:02Z</dcterms:created>
  <dcterms:modified xsi:type="dcterms:W3CDTF">2023-09-06T23:57:17Z</dcterms:modified>
</cp:coreProperties>
</file>